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60896C-82C7-4483-A932-05FED3355ED3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98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ure E14. Peripheral blood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MAIT-cell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frequencies  over the course of the year and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after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oral corticosteroi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 and b. Frequencies of peripheral blood MAIT (Vα7.2+CD161+) cells and a non-MAIT T cell population (Vα7.2+CD161- cells) in 12 moderate asthmatic subjects, usually controlled on inhaled corticosteroids, before and after 7 days of treatment with 20 milligrams of oral prednisolone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given once daily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Frequencies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are shown as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 percentage of live CD3+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T-cells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P values are for paired t tests: *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5, **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1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. Peripheral blood MAIT-cell frequencies vary over the course of the year and are highest in the summer month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og-transformed Vα7.2+CD161+ cell frequencies from healthy and asthmatic subjects according to the quarter in which phlebotomy was performed, with a sinusoidal regression line. 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0.16. ANOVA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001 with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ost-ho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Dunnett’s *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5 and **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1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hen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ompared with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January-March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) Serum vitamin D3 concentrations vary over the course of the year and are highest in the summer month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og-transformed vitamin D3 concentrations from healthy and asthmatic subjects according to the quarter in which phlebotomy was performed, with a sinusoidal regression line. 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0.30. ANOVA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001 with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ost ho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Dunnett’s ***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10 compared with Jan-Mar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09B16A-03FF-4DDE-AEBA-B3CD018F54CE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CA49A-A60C-4B0A-BC85-D775FA369D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7F6D15-8C88-4F58-B6C9-F355AEC0A7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C164B-6121-436C-8E27-A1F8C4DFEE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88635-9D80-497D-A894-987C3BCF53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CE2DCD-A675-41D1-8EBB-B2F0600A41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EF9C9-4803-407D-9B01-C6D0B2E554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1D6BD-16E4-4032-B7A1-F9754F985C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C486E-2A3E-4BEE-ABEA-873D0FE9B0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67809-3991-4506-AB11-D8432D0D64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B1AE08-7640-4A2C-AA85-BA6E6323E4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907406-C71F-47EC-80C7-421C4A7A27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3B311-8588-43FF-8DD4-099E4E4508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376D66-64C3-4E54-B291-95519A69C648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1"/>
          <p:cNvGraphicFramePr/>
          <p:nvPr/>
        </p:nvGraphicFramePr>
        <p:xfrm>
          <a:off x="934920" y="565200"/>
          <a:ext cx="3557880" cy="24429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34920" y="565200"/>
                    <a:ext cx="3557880" cy="2442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Text Box 14"/>
          <p:cNvSpPr/>
          <p:nvPr/>
        </p:nvSpPr>
        <p:spPr>
          <a:xfrm>
            <a:off x="719280" y="139680"/>
            <a:ext cx="180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MAIT cel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4"/>
          <p:cNvSpPr/>
          <p:nvPr/>
        </p:nvSpPr>
        <p:spPr>
          <a:xfrm>
            <a:off x="2835360" y="115920"/>
            <a:ext cx="2023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B. Non-MAIT T cel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96"/>
          <p:cNvSpPr/>
          <p:nvPr/>
        </p:nvSpPr>
        <p:spPr>
          <a:xfrm>
            <a:off x="539640" y="2914560"/>
            <a:ext cx="16034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Before ora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steroid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95"/>
          <p:cNvSpPr/>
          <p:nvPr/>
        </p:nvSpPr>
        <p:spPr>
          <a:xfrm rot="16200000">
            <a:off x="174960" y="1619280"/>
            <a:ext cx="1419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MAIT cell frequenc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96"/>
          <p:cNvSpPr/>
          <p:nvPr/>
        </p:nvSpPr>
        <p:spPr>
          <a:xfrm>
            <a:off x="1490760" y="2914560"/>
            <a:ext cx="16034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fter ora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steroid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95"/>
          <p:cNvSpPr/>
          <p:nvPr/>
        </p:nvSpPr>
        <p:spPr>
          <a:xfrm rot="16200000">
            <a:off x="2032560" y="1626840"/>
            <a:ext cx="15613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PBMC 3C10+CD161-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cell frequenc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96"/>
          <p:cNvSpPr/>
          <p:nvPr/>
        </p:nvSpPr>
        <p:spPr>
          <a:xfrm>
            <a:off x="1077840" y="422280"/>
            <a:ext cx="1602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P=0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0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96"/>
          <p:cNvSpPr/>
          <p:nvPr/>
        </p:nvSpPr>
        <p:spPr>
          <a:xfrm>
            <a:off x="3030480" y="411120"/>
            <a:ext cx="1602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P&gt;0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05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96"/>
          <p:cNvSpPr/>
          <p:nvPr/>
        </p:nvSpPr>
        <p:spPr>
          <a:xfrm>
            <a:off x="2525760" y="2914560"/>
            <a:ext cx="16034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Before ora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steroid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96"/>
          <p:cNvSpPr/>
          <p:nvPr/>
        </p:nvSpPr>
        <p:spPr>
          <a:xfrm>
            <a:off x="3395520" y="2914560"/>
            <a:ext cx="16034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fter ora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steroid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0" name="Object 14"/>
          <p:cNvGraphicFramePr/>
          <p:nvPr/>
        </p:nvGraphicFramePr>
        <p:xfrm>
          <a:off x="1096920" y="4087800"/>
          <a:ext cx="2625840" cy="22464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1" name="Object 1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096920" y="4087800"/>
                    <a:ext cx="2625840" cy="2246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2" name="Text Box 14"/>
          <p:cNvSpPr/>
          <p:nvPr/>
        </p:nvSpPr>
        <p:spPr>
          <a:xfrm>
            <a:off x="650880" y="3429000"/>
            <a:ext cx="384984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. Peripheral MAIT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ell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by date of sample acquisition (quarter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96"/>
          <p:cNvSpPr/>
          <p:nvPr/>
        </p:nvSpPr>
        <p:spPr>
          <a:xfrm>
            <a:off x="1025640" y="6261120"/>
            <a:ext cx="1598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Jan-Ma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95"/>
          <p:cNvSpPr/>
          <p:nvPr/>
        </p:nvSpPr>
        <p:spPr>
          <a:xfrm rot="16200000">
            <a:off x="5400" y="5123880"/>
            <a:ext cx="1669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Ln(MAIT cell frequency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96"/>
          <p:cNvSpPr/>
          <p:nvPr/>
        </p:nvSpPr>
        <p:spPr>
          <a:xfrm>
            <a:off x="1620720" y="6261120"/>
            <a:ext cx="1597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pr-Ju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96"/>
          <p:cNvSpPr/>
          <p:nvPr/>
        </p:nvSpPr>
        <p:spPr>
          <a:xfrm>
            <a:off x="2241720" y="6261120"/>
            <a:ext cx="159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Jul-Se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95"/>
          <p:cNvSpPr/>
          <p:nvPr/>
        </p:nvSpPr>
        <p:spPr>
          <a:xfrm>
            <a:off x="903600" y="6032520"/>
            <a:ext cx="30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-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96"/>
          <p:cNvSpPr/>
          <p:nvPr/>
        </p:nvSpPr>
        <p:spPr>
          <a:xfrm>
            <a:off x="2832120" y="6264360"/>
            <a:ext cx="159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Oct-De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95"/>
          <p:cNvSpPr/>
          <p:nvPr/>
        </p:nvSpPr>
        <p:spPr>
          <a:xfrm>
            <a:off x="919440" y="5694480"/>
            <a:ext cx="30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-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95"/>
          <p:cNvSpPr/>
          <p:nvPr/>
        </p:nvSpPr>
        <p:spPr>
          <a:xfrm>
            <a:off x="906840" y="5335560"/>
            <a:ext cx="30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-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95"/>
          <p:cNvSpPr/>
          <p:nvPr/>
        </p:nvSpPr>
        <p:spPr>
          <a:xfrm>
            <a:off x="929520" y="500220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95"/>
          <p:cNvSpPr/>
          <p:nvPr/>
        </p:nvSpPr>
        <p:spPr>
          <a:xfrm>
            <a:off x="947160" y="463068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95"/>
          <p:cNvSpPr/>
          <p:nvPr/>
        </p:nvSpPr>
        <p:spPr>
          <a:xfrm>
            <a:off x="932760" y="429264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96"/>
          <p:cNvSpPr/>
          <p:nvPr/>
        </p:nvSpPr>
        <p:spPr>
          <a:xfrm>
            <a:off x="3397320" y="3983040"/>
            <a:ext cx="484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96"/>
          <p:cNvSpPr/>
          <p:nvPr/>
        </p:nvSpPr>
        <p:spPr>
          <a:xfrm>
            <a:off x="2774880" y="3983040"/>
            <a:ext cx="484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6" name="Object 12"/>
          <p:cNvGraphicFramePr/>
          <p:nvPr/>
        </p:nvGraphicFramePr>
        <p:xfrm>
          <a:off x="5562720" y="4208400"/>
          <a:ext cx="2963880" cy="20797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77" name="Object 1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562720" y="4208400"/>
                    <a:ext cx="2963880" cy="2079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8" name="Text Box 95"/>
          <p:cNvSpPr/>
          <p:nvPr/>
        </p:nvSpPr>
        <p:spPr>
          <a:xfrm rot="16200000">
            <a:off x="4505400" y="5123520"/>
            <a:ext cx="1114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Ln(Vitamin D3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96"/>
          <p:cNvSpPr/>
          <p:nvPr/>
        </p:nvSpPr>
        <p:spPr>
          <a:xfrm>
            <a:off x="5580000" y="6264360"/>
            <a:ext cx="159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Jan-Ma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96"/>
          <p:cNvSpPr/>
          <p:nvPr/>
        </p:nvSpPr>
        <p:spPr>
          <a:xfrm>
            <a:off x="6238800" y="6264360"/>
            <a:ext cx="1598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pr-Ju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96"/>
          <p:cNvSpPr/>
          <p:nvPr/>
        </p:nvSpPr>
        <p:spPr>
          <a:xfrm>
            <a:off x="6931080" y="6264360"/>
            <a:ext cx="159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Jul-Se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96"/>
          <p:cNvSpPr/>
          <p:nvPr/>
        </p:nvSpPr>
        <p:spPr>
          <a:xfrm>
            <a:off x="7607160" y="6264360"/>
            <a:ext cx="1597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Oct-De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95"/>
          <p:cNvSpPr/>
          <p:nvPr/>
        </p:nvSpPr>
        <p:spPr>
          <a:xfrm>
            <a:off x="5361840" y="592308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95"/>
          <p:cNvSpPr/>
          <p:nvPr/>
        </p:nvSpPr>
        <p:spPr>
          <a:xfrm>
            <a:off x="5368320" y="552924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95"/>
          <p:cNvSpPr/>
          <p:nvPr/>
        </p:nvSpPr>
        <p:spPr>
          <a:xfrm>
            <a:off x="5353920" y="516888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95"/>
          <p:cNvSpPr/>
          <p:nvPr/>
        </p:nvSpPr>
        <p:spPr>
          <a:xfrm>
            <a:off x="5353920" y="483552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95"/>
          <p:cNvSpPr/>
          <p:nvPr/>
        </p:nvSpPr>
        <p:spPr>
          <a:xfrm>
            <a:off x="5371560" y="446400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52"/>
          <p:cNvSpPr/>
          <p:nvPr/>
        </p:nvSpPr>
        <p:spPr>
          <a:xfrm flipH="1">
            <a:off x="5603400" y="496872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Straight Connector 53"/>
          <p:cNvSpPr/>
          <p:nvPr/>
        </p:nvSpPr>
        <p:spPr>
          <a:xfrm flipH="1">
            <a:off x="5603400" y="460368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Straight Connector 55"/>
          <p:cNvSpPr/>
          <p:nvPr/>
        </p:nvSpPr>
        <p:spPr>
          <a:xfrm flipH="1">
            <a:off x="5606640" y="606276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Straight Connector 56"/>
          <p:cNvSpPr/>
          <p:nvPr/>
        </p:nvSpPr>
        <p:spPr>
          <a:xfrm flipH="1">
            <a:off x="5606640" y="569736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Straight Connector 57"/>
          <p:cNvSpPr/>
          <p:nvPr/>
        </p:nvSpPr>
        <p:spPr>
          <a:xfrm flipH="1">
            <a:off x="5606640" y="533412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14"/>
          <p:cNvSpPr/>
          <p:nvPr/>
        </p:nvSpPr>
        <p:spPr>
          <a:xfrm>
            <a:off x="5032440" y="3429000"/>
            <a:ext cx="3571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. Serum Vitamin D3 by date of sample acquisition (quarter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96"/>
          <p:cNvSpPr/>
          <p:nvPr/>
        </p:nvSpPr>
        <p:spPr>
          <a:xfrm>
            <a:off x="8067600" y="3994200"/>
            <a:ext cx="673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96"/>
          <p:cNvSpPr/>
          <p:nvPr/>
        </p:nvSpPr>
        <p:spPr>
          <a:xfrm>
            <a:off x="7380360" y="3994200"/>
            <a:ext cx="628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96"/>
          <p:cNvSpPr/>
          <p:nvPr/>
        </p:nvSpPr>
        <p:spPr>
          <a:xfrm>
            <a:off x="6705720" y="3994200"/>
            <a:ext cx="674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13:19:05Z</dcterms:created>
  <dc:creator>Hinks T.</dc:creator>
  <dc:description/>
  <dc:language>en-US</dc:language>
  <cp:lastModifiedBy>Hinks T.</cp:lastModifiedBy>
  <cp:lastPrinted>2013-09-25T09:00:55Z</cp:lastPrinted>
  <dcterms:modified xsi:type="dcterms:W3CDTF">2015-02-09T14:50:32Z</dcterms:modified>
  <cp:revision>278</cp:revision>
  <dc:subject/>
  <dc:title>PowerPoint Presentation</dc:title>
</cp:coreProperties>
</file>